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F76769-EE14-44ED-B086-37F85AFC06F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E6E673-ECD2-489A-85F2-D00EEBCD06E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4E5C0-DC89-429C-9F0B-61933ECBC0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81874-53B9-47F4-B153-3F21EC24E9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55DB0-01B3-47F0-9EE6-D1EC64D3D6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7630B-0D38-4A9E-B87F-96454802D7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98685-90E7-4E71-8A14-F0EF879951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23EA5-2AD2-445A-BB47-80A22F3F27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0696E1-BD5A-4CA8-9F19-418CF2DA73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CD645-06AB-4002-BF5B-ED92544A79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21A69-32DC-4FC3-845B-DC309DBADD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5DE04-4D71-49E0-A45E-1435241B7F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11E47-613A-48F4-8FAD-5AB63EDC33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63384-2480-408A-B4FB-232B6F566A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008367-7017-4CB9-B58E-DFDB74C8EF2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rcRect l="0" t="0" r="0" b="386"/>
          <a:stretch/>
        </p:blipFill>
        <p:spPr>
          <a:xfrm>
            <a:off x="609480" y="1143000"/>
            <a:ext cx="5181840" cy="4238640"/>
          </a:xfrm>
          <a:prstGeom prst="rect">
            <a:avLst/>
          </a:prstGeom>
          <a:ln w="0">
            <a:noFill/>
          </a:ln>
        </p:spPr>
      </p:pic>
      <p:sp>
        <p:nvSpPr>
          <p:cNvPr id="49" name="Text Box 3"/>
          <p:cNvSpPr/>
          <p:nvPr/>
        </p:nvSpPr>
        <p:spPr>
          <a:xfrm>
            <a:off x="609480" y="5754600"/>
            <a:ext cx="56390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Consensus plot of genome-wide copy number gains and losses in the 20 lymph node metastatic OSCC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ray lines indicate percentages of copy number gains (red)/losses (green), range from 0, 20%, 40%, 60%, 80% and 100% percent. Colored vertical lines indicate percentages of copy number gains/losses among the chromosomes. The higher the vertical colored lines, the higher percent of patients had copy number gains/losses at the particular chromosomal region in the tumor sampl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7T18:58:03Z</dcterms:created>
  <dc:creator>cxu</dc:creator>
  <dc:description/>
  <dc:language>en-US</dc:language>
  <cp:lastModifiedBy> </cp:lastModifiedBy>
  <dcterms:modified xsi:type="dcterms:W3CDTF">2010-06-09T13:59:16Z</dcterms:modified>
  <cp:revision>136</cp:revision>
  <dc:subject/>
  <dc:title>Slide 1</dc:title>
</cp:coreProperties>
</file>